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550" r:id="rId2"/>
    <p:sldId id="551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3CB06D9-03E9-294E-899D-C0244F764E6D}" v="161" dt="2025-03-14T10:23:30.54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250"/>
    <p:restoredTop sz="94730"/>
  </p:normalViewPr>
  <p:slideViewPr>
    <p:cSldViewPr snapToGrid="0" snapToObjects="1">
      <p:cViewPr varScale="1">
        <p:scale>
          <a:sx n="75" d="100"/>
          <a:sy n="75" d="100"/>
        </p:scale>
        <p:origin x="176" y="11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FCA846-4F47-514A-AAEE-FD05E17B5B5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2D3D4A-FFEC-D744-BED7-9004525289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13665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74E4BA2-F2AA-AE47-B8F0-DFE5641E49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0AFBEEF-BF67-FE4B-B29F-458BECCE76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BFCD6A0-CAED-A84C-A38B-F14F088DD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EC1FD71-4357-584E-9896-E01EF2E7F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5A2999D-E073-7B48-B2D1-14B75DC4E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965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9C797CD-83B9-1D41-AD55-FCC672FC9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08C22D0-D50B-1740-9FC2-3836A79CA7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9CEBBB6-5DE5-3D41-A905-96ADBCB18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AAC4DAA-855E-0B40-A09A-FD5577821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F099258-2F0D-A54A-AB33-F2EDE0732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3745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6BE8874-D599-AB49-96D1-3AB52BAB44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BFA5AAB-F5D7-0C44-8D77-8FAFCB0C0C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C797E8F-87F6-B24B-AF65-6445BCEC5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E54105-9757-414C-9C5B-7B3953AFA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158CEFE-1DF4-9746-8A29-7F6BBE010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4107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7C3AD4-3035-E64F-A8B1-29E974995A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8A321EA-4861-BE42-BE93-17972D44AF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AD8E30-9405-5149-BCED-339B9A3B1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48FACBF-A9AD-504E-BDCD-0E81C0B1F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1297AA2-F4E1-D347-88F7-8111C5788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5697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1B42D0B-FB29-D149-AC6A-13025D1ED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282C7B2-EB84-F044-A864-0E397EEE6D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06C5AB2-6ED5-9747-914C-E7EF4A7EC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00CF31B-7BEF-7B49-BF39-CA25A4262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8087709-5A33-924C-90C0-4FE90D3DE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5421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63775E-B0BE-744D-A142-E699C5E4F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174B3AB-DE57-0943-BAF9-5796860CFF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9F18A89-A55A-7044-94AB-AF1E4CC66B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A5808EE-8F04-E042-971E-B7576DE23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B30022D-965E-3E4C-81D9-4DE486CA6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83946F4-6291-1047-9618-8C1523747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863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9D27CA9-93F7-3342-9D8A-B22A7D7FFF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5AD1498-6FC5-E040-9329-43FB06EE79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29CF3F1-030D-624D-B241-7B0964A727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A01B1AE-D872-7444-B014-D396B89C61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32A0BBB-18F0-0D4F-98F7-B53A5CFC51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CDE67C5-F70C-0D4E-8208-27BCF23D6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BF120DF-6966-8F41-AB32-95BAF9B28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27DC3108-1D3A-1145-B139-AEA4FAEA2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908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DE3871-8B1F-7B4A-876A-4EF6167F14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6C4CE90-22C3-A44B-9FA2-0491E6C62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142B065-C2AC-4744-9BCF-3E5729944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0A6FC32-D690-C54C-901F-B8E2787D0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9322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860BC2C-8130-9B40-8601-A4A7868A5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0183179-A0FA-BB48-B9E7-CD8C11ADC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D2782FA-E46B-6247-BFBB-C3F7F4AABD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7104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52EAECE-4037-744F-B579-60A1706A8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43AF964-A02E-A448-8CD3-12E5FF6C42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036E6DE-818A-794A-92F7-B4854A2FC5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68CE8CF-9E6B-6746-A015-27671E969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53DBE09-9463-764B-A2BC-D9B271AE5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46A63FD-B8C2-D241-9436-4ADBE32BF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9934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B95ACA-DD51-034D-BA2A-C65941BB4B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3805E4A-5112-AE4F-A011-30F3AF8E95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84D8E4B-7AE5-DE4C-8AEE-8C6C03F974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518B980-7A29-D54E-9721-26DFD3233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9A4881E-AF9F-F548-8506-AD1E574D1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2080C45-EAC0-2746-8644-AAB720D1C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3242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C71166C-584B-7A4D-A505-E90551AEC7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BAD96A2-906F-6041-BC92-3F14F345E4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89B1B1-F0CE-0A4E-820B-A5F24BEB46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BD1EA18-72C0-4D46-B066-6BB971AC18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41766D8-BE28-134F-99E5-0B1CF11EE7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3325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18D4112-A746-CB14-49D9-60D1242D81A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BB97F72-E347-A0BB-EA89-A59702781B63}"/>
              </a:ext>
            </a:extLst>
          </p:cNvPr>
          <p:cNvSpPr txBox="1"/>
          <p:nvPr/>
        </p:nvSpPr>
        <p:spPr>
          <a:xfrm>
            <a:off x="9618113" y="0"/>
            <a:ext cx="256268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2E</a:t>
            </a:r>
          </a:p>
          <a:p>
            <a:r>
              <a:rPr lang="en-US" b="1" dirty="0"/>
              <a:t>pY705-STAT3 </a:t>
            </a:r>
          </a:p>
          <a:p>
            <a:r>
              <a:rPr lang="en-US" b="1" dirty="0"/>
              <a:t>+ </a:t>
            </a:r>
            <a:r>
              <a:rPr lang="en-GB" b="1" dirty="0"/>
              <a:t>STAT3 </a:t>
            </a:r>
            <a:r>
              <a:rPr lang="en-US" b="1" dirty="0"/>
              <a:t>Blots</a:t>
            </a:r>
          </a:p>
        </p:txBody>
      </p:sp>
      <p:sp>
        <p:nvSpPr>
          <p:cNvPr id="5" name="ZoneTexte 10">
            <a:extLst>
              <a:ext uri="{FF2B5EF4-FFF2-40B4-BE49-F238E27FC236}">
                <a16:creationId xmlns:a16="http://schemas.microsoft.com/office/drawing/2014/main" id="{F07AE95D-C194-2CDB-AFC5-854E5B8C93E6}"/>
              </a:ext>
            </a:extLst>
          </p:cNvPr>
          <p:cNvSpPr txBox="1"/>
          <p:nvPr/>
        </p:nvSpPr>
        <p:spPr>
          <a:xfrm>
            <a:off x="9600397" y="1306048"/>
            <a:ext cx="3681238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-</a:t>
            </a:r>
            <a:r>
              <a:rPr lang="fr-FR" sz="1400" dirty="0" err="1"/>
              <a:t>Ste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KML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P</a:t>
            </a:r>
            <a:r>
              <a:rPr lang="en-GB" sz="1400" baseline="30000" dirty="0">
                <a:cs typeface="Arial" panose="020B0604020202020204" pitchFamily="34" charset="0"/>
              </a:rPr>
              <a:t>-FS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KML</a:t>
            </a:r>
            <a:r>
              <a:rPr lang="en-GB" sz="1400" baseline="30000" dirty="0">
                <a:cs typeface="Arial" panose="020B0604020202020204" pitchFamily="34" charset="0"/>
              </a:rPr>
              <a:t>FS-SP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613A50B-28AA-6BD2-A119-BE3C080C38B0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DFEB105A-157F-AC5B-6EB0-5EDEB1C2D668}"/>
              </a:ext>
            </a:extLst>
          </p:cNvPr>
          <p:cNvGrpSpPr/>
          <p:nvPr/>
        </p:nvGrpSpPr>
        <p:grpSpPr>
          <a:xfrm>
            <a:off x="1235022" y="1368975"/>
            <a:ext cx="3592005" cy="1064300"/>
            <a:chOff x="998600" y="1300977"/>
            <a:chExt cx="3592005" cy="106430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DE4C38C1-4266-B180-1A20-ED53679855B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8686" t="26029" r="62549" b="63258"/>
            <a:stretch/>
          </p:blipFill>
          <p:spPr>
            <a:xfrm>
              <a:off x="998600" y="1700429"/>
              <a:ext cx="1458448" cy="664848"/>
            </a:xfrm>
            <a:prstGeom prst="rect">
              <a:avLst/>
            </a:prstGeom>
          </p:spPr>
        </p:pic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3413D5B2-6C03-9AC4-AF21-977722D37459}"/>
                </a:ext>
              </a:extLst>
            </p:cNvPr>
            <p:cNvGrpSpPr/>
            <p:nvPr/>
          </p:nvGrpSpPr>
          <p:grpSpPr>
            <a:xfrm>
              <a:off x="1112369" y="1300977"/>
              <a:ext cx="3478236" cy="1005072"/>
              <a:chOff x="673598" y="709837"/>
              <a:chExt cx="3478236" cy="1005072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61B8C633-DF82-0AD5-D30F-8BBF2C0099EC}"/>
                  </a:ext>
                </a:extLst>
              </p:cNvPr>
              <p:cNvSpPr txBox="1"/>
              <p:nvPr/>
            </p:nvSpPr>
            <p:spPr>
              <a:xfrm>
                <a:off x="711621" y="716650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1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1BDBF4A1-7512-6AE4-0764-F9495321A55B}"/>
                  </a:ext>
                </a:extLst>
              </p:cNvPr>
              <p:cNvSpPr txBox="1"/>
              <p:nvPr/>
            </p:nvSpPr>
            <p:spPr>
              <a:xfrm>
                <a:off x="949509" y="714379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2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55FDE8FD-6220-15B1-A200-163668F93F95}"/>
                  </a:ext>
                </a:extLst>
              </p:cNvPr>
              <p:cNvSpPr txBox="1"/>
              <p:nvPr/>
            </p:nvSpPr>
            <p:spPr>
              <a:xfrm>
                <a:off x="1171743" y="712108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3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FFFD9667-83F5-34C6-56FC-7EA3583B4EEC}"/>
                  </a:ext>
                </a:extLst>
              </p:cNvPr>
              <p:cNvSpPr txBox="1"/>
              <p:nvPr/>
            </p:nvSpPr>
            <p:spPr>
              <a:xfrm>
                <a:off x="1388333" y="709837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4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9A7CB81-6CAB-CCC6-B403-5D21258BF636}"/>
                  </a:ext>
                </a:extLst>
              </p:cNvPr>
              <p:cNvSpPr txBox="1"/>
              <p:nvPr/>
            </p:nvSpPr>
            <p:spPr>
              <a:xfrm>
                <a:off x="1586677" y="716650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5</a:t>
                </a: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EDB871D5-92A0-0779-762D-65101819C873}"/>
                  </a:ext>
                </a:extLst>
              </p:cNvPr>
              <p:cNvSpPr/>
              <p:nvPr/>
            </p:nvSpPr>
            <p:spPr>
              <a:xfrm>
                <a:off x="673598" y="1337882"/>
                <a:ext cx="1214765" cy="36422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2342DD71-B9DA-D6F5-E25A-8668E7AC9102}"/>
                  </a:ext>
                </a:extLst>
              </p:cNvPr>
              <p:cNvSpPr txBox="1"/>
              <p:nvPr/>
            </p:nvSpPr>
            <p:spPr>
              <a:xfrm>
                <a:off x="2055941" y="1253244"/>
                <a:ext cx="2095893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l-GR" sz="1200" dirty="0"/>
                  <a:t>α</a:t>
                </a:r>
                <a:r>
                  <a:rPr lang="en-GB" sz="1200" dirty="0"/>
                  <a:t>-pY705-STAT3</a:t>
                </a:r>
                <a:r>
                  <a:rPr lang="fr-FR" sz="1200" dirty="0"/>
                  <a:t> Blot</a:t>
                </a:r>
              </a:p>
              <a:p>
                <a:r>
                  <a:rPr lang="fr-FR" sz="1200" dirty="0"/>
                  <a:t>Chimiluminescence image</a:t>
                </a:r>
                <a:endParaRPr lang="en-US" sz="1200" dirty="0"/>
              </a:p>
            </p:txBody>
          </p:sp>
        </p:grp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314795FE-E427-ACE7-88F1-CFA81A31C967}"/>
              </a:ext>
            </a:extLst>
          </p:cNvPr>
          <p:cNvGrpSpPr/>
          <p:nvPr/>
        </p:nvGrpSpPr>
        <p:grpSpPr>
          <a:xfrm>
            <a:off x="721207" y="2906486"/>
            <a:ext cx="4328625" cy="1796505"/>
            <a:chOff x="840094" y="3187201"/>
            <a:chExt cx="4328625" cy="1796505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48468BBC-5B09-43E8-B26E-D109ADC60F0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0008" t="24382" r="62153" b="63167"/>
            <a:stretch/>
          </p:blipFill>
          <p:spPr>
            <a:xfrm>
              <a:off x="1452078" y="3858259"/>
              <a:ext cx="1386490" cy="772730"/>
            </a:xfrm>
            <a:prstGeom prst="rect">
              <a:avLst/>
            </a:prstGeom>
          </p:spPr>
        </p:pic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3544FB59-FBA1-390B-11BA-CD11DD06CFC0}"/>
                </a:ext>
              </a:extLst>
            </p:cNvPr>
            <p:cNvGrpSpPr/>
            <p:nvPr/>
          </p:nvGrpSpPr>
          <p:grpSpPr>
            <a:xfrm>
              <a:off x="840094" y="3187201"/>
              <a:ext cx="4328625" cy="1796505"/>
              <a:chOff x="1044920" y="3174544"/>
              <a:chExt cx="4328625" cy="1796505"/>
            </a:xfrm>
          </p:grpSpPr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4724CEF5-B0ED-E86B-EAC3-77AD7527ED32}"/>
                  </a:ext>
                </a:extLst>
              </p:cNvPr>
              <p:cNvGrpSpPr/>
              <p:nvPr/>
            </p:nvGrpSpPr>
            <p:grpSpPr>
              <a:xfrm>
                <a:off x="1044920" y="3853060"/>
                <a:ext cx="4328625" cy="1117989"/>
                <a:chOff x="285847" y="2570871"/>
                <a:chExt cx="4328625" cy="1117989"/>
              </a:xfrm>
            </p:grpSpPr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81419E47-5866-D575-5303-1C275CF5ABB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61395" y="3182439"/>
                  <a:ext cx="270226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7D2D6F7E-849E-FABD-5428-7CE31FA10428}"/>
                    </a:ext>
                  </a:extLst>
                </p:cNvPr>
                <p:cNvSpPr txBox="1"/>
                <p:nvPr/>
              </p:nvSpPr>
              <p:spPr>
                <a:xfrm>
                  <a:off x="285847" y="3023134"/>
                  <a:ext cx="54455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/>
                    <a:t>75</a:t>
                  </a:r>
                </a:p>
              </p:txBody>
            </p:sp>
            <p:sp>
              <p:nvSpPr>
                <p:cNvPr id="35" name="ZoneTexte 32">
                  <a:extLst>
                    <a:ext uri="{FF2B5EF4-FFF2-40B4-BE49-F238E27FC236}">
                      <a16:creationId xmlns:a16="http://schemas.microsoft.com/office/drawing/2014/main" id="{30ED5B54-061C-CD7B-9D6F-9D4490F76B4C}"/>
                    </a:ext>
                  </a:extLst>
                </p:cNvPr>
                <p:cNvSpPr txBox="1"/>
                <p:nvPr/>
              </p:nvSpPr>
              <p:spPr>
                <a:xfrm>
                  <a:off x="2410535" y="2673197"/>
                  <a:ext cx="2203937" cy="10156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200" dirty="0"/>
                    <a:t>α</a:t>
                  </a:r>
                  <a:r>
                    <a:rPr lang="en-GB" sz="1200" dirty="0"/>
                    <a:t>-pY705-STAT3</a:t>
                  </a:r>
                  <a:endParaRPr lang="fr-FR" sz="1200" dirty="0"/>
                </a:p>
                <a:p>
                  <a:r>
                    <a:rPr lang="fr-FR" sz="1200" dirty="0"/>
                    <a:t>Chimiluminescence image</a:t>
                  </a:r>
                </a:p>
                <a:p>
                  <a:r>
                    <a:rPr lang="fr-FR" sz="1200" dirty="0"/>
                    <a:t>+ Membrane overlay</a:t>
                  </a:r>
                </a:p>
                <a:p>
                  <a:endParaRPr lang="fr-FR" sz="1200" dirty="0"/>
                </a:p>
                <a:p>
                  <a:r>
                    <a:rPr lang="fr-FR" sz="1200" dirty="0">
                      <a:sym typeface="Wingdings" pitchFamily="2" charset="2"/>
                    </a:rPr>
                    <a:t> </a:t>
                  </a:r>
                  <a:r>
                    <a:rPr lang="fr-FR" sz="1200" dirty="0"/>
                    <a:t>Membrane </a:t>
                  </a:r>
                  <a:r>
                    <a:rPr lang="fr-FR" sz="1200" dirty="0" err="1"/>
                    <a:t>cut</a:t>
                  </a:r>
                  <a:r>
                    <a:rPr lang="fr-FR" sz="1200" dirty="0"/>
                    <a:t> </a:t>
                  </a:r>
                  <a:r>
                    <a:rPr lang="fr-FR" sz="1200" dirty="0" err="1"/>
                    <a:t>below</a:t>
                  </a:r>
                  <a:r>
                    <a:rPr lang="fr-FR" sz="1200" dirty="0"/>
                    <a:t> 75 KDa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54AA526D-F92D-6AE0-B2BE-13238EC732DA}"/>
                    </a:ext>
                  </a:extLst>
                </p:cNvPr>
                <p:cNvSpPr txBox="1"/>
                <p:nvPr/>
              </p:nvSpPr>
              <p:spPr>
                <a:xfrm>
                  <a:off x="285847" y="2570871"/>
                  <a:ext cx="50206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err="1"/>
                    <a:t>kDa</a:t>
                  </a:r>
                  <a:endParaRPr lang="en-US" sz="1600" dirty="0"/>
                </a:p>
              </p:txBody>
            </p:sp>
          </p:grp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46030BD3-68E8-0BEE-5C45-2895B5C2921A}"/>
                  </a:ext>
                </a:extLst>
              </p:cNvPr>
              <p:cNvSpPr txBox="1"/>
              <p:nvPr/>
            </p:nvSpPr>
            <p:spPr>
              <a:xfrm rot="18528072">
                <a:off x="1521000" y="3384538"/>
                <a:ext cx="75854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solidFill>
                      <a:srgbClr val="C00000"/>
                    </a:solidFill>
                  </a:rPr>
                  <a:t>Ladder</a:t>
                </a:r>
              </a:p>
            </p:txBody>
          </p:sp>
        </p:grpSp>
      </p:grpSp>
      <p:grpSp>
        <p:nvGrpSpPr>
          <p:cNvPr id="57" name="Group 56">
            <a:extLst>
              <a:ext uri="{FF2B5EF4-FFF2-40B4-BE49-F238E27FC236}">
                <a16:creationId xmlns:a16="http://schemas.microsoft.com/office/drawing/2014/main" id="{B5B97942-643F-00A0-406A-794812AD396A}"/>
              </a:ext>
            </a:extLst>
          </p:cNvPr>
          <p:cNvGrpSpPr/>
          <p:nvPr/>
        </p:nvGrpSpPr>
        <p:grpSpPr>
          <a:xfrm>
            <a:off x="5587524" y="1222606"/>
            <a:ext cx="3546538" cy="1246814"/>
            <a:chOff x="4656422" y="1327612"/>
            <a:chExt cx="3546538" cy="1246814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BA8902D6-B626-678D-4AFA-A35294FE19E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19711" t="11748" r="62451" b="71886"/>
            <a:stretch/>
          </p:blipFill>
          <p:spPr>
            <a:xfrm>
              <a:off x="4656422" y="1558762"/>
              <a:ext cx="1386490" cy="1015664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8585902-B539-AAE4-E6CA-DCBA4ACDF095}"/>
                </a:ext>
              </a:extLst>
            </p:cNvPr>
            <p:cNvSpPr txBox="1"/>
            <p:nvPr/>
          </p:nvSpPr>
          <p:spPr>
            <a:xfrm>
              <a:off x="4837803" y="1327612"/>
              <a:ext cx="3016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F5840DF-C88E-E465-9B00-62EEACF02087}"/>
                </a:ext>
              </a:extLst>
            </p:cNvPr>
            <p:cNvSpPr txBox="1"/>
            <p:nvPr/>
          </p:nvSpPr>
          <p:spPr>
            <a:xfrm>
              <a:off x="5047981" y="1327612"/>
              <a:ext cx="3016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C3620D8-D8E4-BD37-8920-FB026EAD4588}"/>
                </a:ext>
              </a:extLst>
            </p:cNvPr>
            <p:cNvSpPr txBox="1"/>
            <p:nvPr/>
          </p:nvSpPr>
          <p:spPr>
            <a:xfrm>
              <a:off x="5242505" y="1327612"/>
              <a:ext cx="3016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3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179ECFF-00F0-3A9D-F384-719B1B14BA1F}"/>
                </a:ext>
              </a:extLst>
            </p:cNvPr>
            <p:cNvSpPr txBox="1"/>
            <p:nvPr/>
          </p:nvSpPr>
          <p:spPr>
            <a:xfrm>
              <a:off x="5425843" y="1327612"/>
              <a:ext cx="3016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4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A58FCC2-BF33-FEB8-D717-74AF43380F7B}"/>
                </a:ext>
              </a:extLst>
            </p:cNvPr>
            <p:cNvSpPr txBox="1"/>
            <p:nvPr/>
          </p:nvSpPr>
          <p:spPr>
            <a:xfrm>
              <a:off x="5629729" y="1327612"/>
              <a:ext cx="3016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5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6B8E1E8C-7390-32FA-DBFD-0DC4DADB0409}"/>
                </a:ext>
              </a:extLst>
            </p:cNvPr>
            <p:cNvSpPr/>
            <p:nvPr/>
          </p:nvSpPr>
          <p:spPr>
            <a:xfrm>
              <a:off x="4837803" y="2102026"/>
              <a:ext cx="1093612" cy="267944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93857F7C-48E1-06D2-DBC0-AD4542EADAB6}"/>
                </a:ext>
              </a:extLst>
            </p:cNvPr>
            <p:cNvSpPr txBox="1"/>
            <p:nvPr/>
          </p:nvSpPr>
          <p:spPr>
            <a:xfrm>
              <a:off x="6107067" y="1858218"/>
              <a:ext cx="2095893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1200" dirty="0"/>
                <a:t>α</a:t>
              </a:r>
              <a:r>
                <a:rPr lang="en-GB" sz="1200" dirty="0"/>
                <a:t>-STAT3</a:t>
              </a:r>
              <a:r>
                <a:rPr lang="fr-FR" sz="1200" dirty="0"/>
                <a:t> Blot</a:t>
              </a:r>
            </a:p>
            <a:p>
              <a:r>
                <a:rPr lang="fr-FR" sz="1200" dirty="0"/>
                <a:t>Chimiluminescence image</a:t>
              </a:r>
              <a:endParaRPr lang="en-US" sz="1200" dirty="0"/>
            </a:p>
          </p:txBody>
        </p:sp>
      </p:grpSp>
      <p:grpSp>
        <p:nvGrpSpPr>
          <p:cNvPr id="55" name="Group 54">
            <a:extLst>
              <a:ext uri="{FF2B5EF4-FFF2-40B4-BE49-F238E27FC236}">
                <a16:creationId xmlns:a16="http://schemas.microsoft.com/office/drawing/2014/main" id="{9AAE48A4-D237-98D2-3A7C-37EA2FDC6F68}"/>
              </a:ext>
            </a:extLst>
          </p:cNvPr>
          <p:cNvGrpSpPr/>
          <p:nvPr/>
        </p:nvGrpSpPr>
        <p:grpSpPr>
          <a:xfrm>
            <a:off x="5223497" y="2778220"/>
            <a:ext cx="4201836" cy="1796375"/>
            <a:chOff x="4220248" y="2599850"/>
            <a:chExt cx="4201836" cy="1796375"/>
          </a:xfrm>
        </p:grpSpPr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CDC463DA-278D-BC59-5A7D-A44A99BDC08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19855" t="12821" r="62307" b="73741"/>
            <a:stretch/>
          </p:blipFill>
          <p:spPr>
            <a:xfrm>
              <a:off x="4744039" y="3278237"/>
              <a:ext cx="1386490" cy="833993"/>
            </a:xfrm>
            <a:prstGeom prst="rect">
              <a:avLst/>
            </a:prstGeom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B9C039A-D258-DB6B-1609-2C647918374F}"/>
                </a:ext>
              </a:extLst>
            </p:cNvPr>
            <p:cNvSpPr txBox="1"/>
            <p:nvPr/>
          </p:nvSpPr>
          <p:spPr>
            <a:xfrm rot="18528072">
              <a:off x="4646731" y="2809844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C00000"/>
                  </a:solidFill>
                </a:rPr>
                <a:t>Ladder</a:t>
              </a: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20074869-15DB-F3BD-E38E-472ED1832CE4}"/>
                </a:ext>
              </a:extLst>
            </p:cNvPr>
            <p:cNvCxnSpPr>
              <a:cxnSpLocks/>
            </p:cNvCxnSpPr>
            <p:nvPr/>
          </p:nvCxnSpPr>
          <p:spPr>
            <a:xfrm>
              <a:off x="4567577" y="3971460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3F2B94C-A5D9-9578-14A5-0F12C55C759F}"/>
                </a:ext>
              </a:extLst>
            </p:cNvPr>
            <p:cNvSpPr txBox="1"/>
            <p:nvPr/>
          </p:nvSpPr>
          <p:spPr>
            <a:xfrm>
              <a:off x="4220248" y="3802183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75</a:t>
              </a:r>
            </a:p>
          </p:txBody>
        </p:sp>
        <p:sp>
          <p:nvSpPr>
            <p:cNvPr id="54" name="ZoneTexte 32">
              <a:extLst>
                <a:ext uri="{FF2B5EF4-FFF2-40B4-BE49-F238E27FC236}">
                  <a16:creationId xmlns:a16="http://schemas.microsoft.com/office/drawing/2014/main" id="{12B4BE82-A22D-D09F-E057-BC9E32951172}"/>
                </a:ext>
              </a:extLst>
            </p:cNvPr>
            <p:cNvSpPr txBox="1"/>
            <p:nvPr/>
          </p:nvSpPr>
          <p:spPr>
            <a:xfrm>
              <a:off x="6218147" y="3380562"/>
              <a:ext cx="2203937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/>
                <a:t>α</a:t>
              </a:r>
              <a:r>
                <a:rPr lang="en-GB" sz="1200" dirty="0"/>
                <a:t>-STAT3</a:t>
              </a:r>
              <a:endParaRPr lang="fr-FR" sz="1200" dirty="0"/>
            </a:p>
            <a:p>
              <a:r>
                <a:rPr lang="fr-FR" sz="1200" dirty="0"/>
                <a:t>Chimiluminescence image</a:t>
              </a:r>
            </a:p>
            <a:p>
              <a:r>
                <a:rPr lang="fr-FR" sz="1200" dirty="0"/>
                <a:t>+ Membrane overlay</a:t>
              </a:r>
            </a:p>
            <a:p>
              <a:endParaRPr lang="fr-FR" sz="1200" dirty="0"/>
            </a:p>
            <a:p>
              <a:r>
                <a:rPr lang="fr-FR" sz="1200" dirty="0">
                  <a:sym typeface="Wingdings" pitchFamily="2" charset="2"/>
                </a:rPr>
                <a:t> </a:t>
              </a:r>
              <a:r>
                <a:rPr lang="fr-FR" sz="1200" dirty="0"/>
                <a:t>Membrane </a:t>
              </a:r>
              <a:r>
                <a:rPr lang="fr-FR" sz="1200" dirty="0" err="1"/>
                <a:t>cut</a:t>
              </a:r>
              <a:r>
                <a:rPr lang="fr-FR" sz="1200" dirty="0"/>
                <a:t> </a:t>
              </a:r>
              <a:r>
                <a:rPr lang="fr-FR" sz="1200" dirty="0" err="1"/>
                <a:t>below</a:t>
              </a:r>
              <a:r>
                <a:rPr lang="fr-FR" sz="1200" dirty="0"/>
                <a:t> 75 KD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581137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B2C89AD-CF64-CD9C-1E20-9699AD9AA8A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B45A4327-EFE9-5129-FA66-CA625515310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0348" t="33001" r="54220" b="38385"/>
          <a:stretch/>
        </p:blipFill>
        <p:spPr>
          <a:xfrm>
            <a:off x="1319354" y="3980553"/>
            <a:ext cx="1199502" cy="177578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792139B-B3C3-A909-6CD8-396508521D4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249" t="33021" r="54434" b="44691"/>
          <a:stretch/>
        </p:blipFill>
        <p:spPr>
          <a:xfrm>
            <a:off x="1143460" y="1852015"/>
            <a:ext cx="1345957" cy="138312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78765F9-110B-81C1-768B-F3D3A3B6AA20}"/>
              </a:ext>
            </a:extLst>
          </p:cNvPr>
          <p:cNvSpPr txBox="1"/>
          <p:nvPr/>
        </p:nvSpPr>
        <p:spPr>
          <a:xfrm>
            <a:off x="9618113" y="0"/>
            <a:ext cx="256268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2E</a:t>
            </a:r>
          </a:p>
          <a:p>
            <a:r>
              <a:rPr lang="en-US" b="1" dirty="0"/>
              <a:t>GFP</a:t>
            </a:r>
          </a:p>
          <a:p>
            <a:r>
              <a:rPr lang="en-US" b="1" dirty="0"/>
              <a:t>+ </a:t>
            </a:r>
            <a:r>
              <a:rPr lang="en-GB" b="1" dirty="0"/>
              <a:t>Tubulin </a:t>
            </a:r>
            <a:r>
              <a:rPr lang="en-US" b="1" dirty="0"/>
              <a:t>Blots</a:t>
            </a:r>
          </a:p>
        </p:txBody>
      </p:sp>
      <p:sp>
        <p:nvSpPr>
          <p:cNvPr id="5" name="ZoneTexte 10">
            <a:extLst>
              <a:ext uri="{FF2B5EF4-FFF2-40B4-BE49-F238E27FC236}">
                <a16:creationId xmlns:a16="http://schemas.microsoft.com/office/drawing/2014/main" id="{FA470D08-4D21-2DEF-C3B5-D6918048E609}"/>
              </a:ext>
            </a:extLst>
          </p:cNvPr>
          <p:cNvSpPr txBox="1"/>
          <p:nvPr/>
        </p:nvSpPr>
        <p:spPr>
          <a:xfrm>
            <a:off x="9600397" y="1306048"/>
            <a:ext cx="3681238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-</a:t>
            </a:r>
            <a:r>
              <a:rPr lang="fr-FR" sz="1400" dirty="0" err="1"/>
              <a:t>Ste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KML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P</a:t>
            </a:r>
            <a:r>
              <a:rPr lang="en-GB" sz="1400" baseline="30000" dirty="0">
                <a:cs typeface="Arial" panose="020B0604020202020204" pitchFamily="34" charset="0"/>
              </a:rPr>
              <a:t>-FS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KML</a:t>
            </a:r>
            <a:r>
              <a:rPr lang="en-GB" sz="1400" baseline="30000" dirty="0">
                <a:cs typeface="Arial" panose="020B0604020202020204" pitchFamily="34" charset="0"/>
              </a:rPr>
              <a:t>FS-SP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EEE75F4-A6E8-48F1-6366-E792BA38066F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733AE112-8843-700B-B691-9124AFD8EBFB}"/>
              </a:ext>
            </a:extLst>
          </p:cNvPr>
          <p:cNvGrpSpPr/>
          <p:nvPr/>
        </p:nvGrpSpPr>
        <p:grpSpPr>
          <a:xfrm>
            <a:off x="1438130" y="1368975"/>
            <a:ext cx="3258359" cy="1278983"/>
            <a:chOff x="762937" y="709837"/>
            <a:chExt cx="3258359" cy="1278983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1242F4C-F442-7209-CBD2-1F75189FF63B}"/>
                </a:ext>
              </a:extLst>
            </p:cNvPr>
            <p:cNvSpPr txBox="1"/>
            <p:nvPr/>
          </p:nvSpPr>
          <p:spPr>
            <a:xfrm>
              <a:off x="762937" y="71665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F26D159-FDB5-EACE-453A-59EAC2A9A473}"/>
                </a:ext>
              </a:extLst>
            </p:cNvPr>
            <p:cNvSpPr txBox="1"/>
            <p:nvPr/>
          </p:nvSpPr>
          <p:spPr>
            <a:xfrm>
              <a:off x="972834" y="714379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04283B5-62CF-6B79-DA78-773940DC83A7}"/>
                </a:ext>
              </a:extLst>
            </p:cNvPr>
            <p:cNvSpPr txBox="1"/>
            <p:nvPr/>
          </p:nvSpPr>
          <p:spPr>
            <a:xfrm>
              <a:off x="1171743" y="71210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0147494-5251-CA29-207D-FCABDFF71C58}"/>
                </a:ext>
              </a:extLst>
            </p:cNvPr>
            <p:cNvSpPr txBox="1"/>
            <p:nvPr/>
          </p:nvSpPr>
          <p:spPr>
            <a:xfrm>
              <a:off x="1388333" y="709837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E39791E-87F3-E7E4-D4BE-AB978D135CCE}"/>
                </a:ext>
              </a:extLst>
            </p:cNvPr>
            <p:cNvSpPr txBox="1"/>
            <p:nvPr/>
          </p:nvSpPr>
          <p:spPr>
            <a:xfrm>
              <a:off x="1586677" y="71665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42A58B60-999C-DCE2-E6C8-9DE94870EBB6}"/>
                </a:ext>
              </a:extLst>
            </p:cNvPr>
            <p:cNvSpPr/>
            <p:nvPr/>
          </p:nvSpPr>
          <p:spPr>
            <a:xfrm>
              <a:off x="762937" y="1337882"/>
              <a:ext cx="1051288" cy="65093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0DA4FEA-D356-1C5C-150C-028040FBCC47}"/>
                </a:ext>
              </a:extLst>
            </p:cNvPr>
            <p:cNvSpPr txBox="1"/>
            <p:nvPr/>
          </p:nvSpPr>
          <p:spPr>
            <a:xfrm>
              <a:off x="1925403" y="1374993"/>
              <a:ext cx="2095893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1200" dirty="0"/>
                <a:t>α</a:t>
              </a:r>
              <a:r>
                <a:rPr lang="en-GB" sz="1200" dirty="0"/>
                <a:t>-GFP</a:t>
              </a:r>
              <a:r>
                <a:rPr lang="fr-FR" sz="1200" dirty="0"/>
                <a:t> Blot</a:t>
              </a:r>
            </a:p>
            <a:p>
              <a:r>
                <a:rPr lang="fr-FR" sz="1200" dirty="0"/>
                <a:t>Chimiluminescence image</a:t>
              </a:r>
              <a:endParaRPr lang="en-US" sz="1200" dirty="0"/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3553B0DF-E85B-242E-6AEA-0C3DA5F3C4A0}"/>
              </a:ext>
            </a:extLst>
          </p:cNvPr>
          <p:cNvGrpSpPr/>
          <p:nvPr/>
        </p:nvGrpSpPr>
        <p:grpSpPr>
          <a:xfrm>
            <a:off x="715419" y="3256932"/>
            <a:ext cx="4074687" cy="1795996"/>
            <a:chOff x="1039132" y="3524990"/>
            <a:chExt cx="4074687" cy="1795996"/>
          </a:xfrm>
        </p:grpSpPr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7E6DA9E0-B234-990F-B349-76E816B8263A}"/>
                </a:ext>
              </a:extLst>
            </p:cNvPr>
            <p:cNvGrpSpPr/>
            <p:nvPr/>
          </p:nvGrpSpPr>
          <p:grpSpPr>
            <a:xfrm>
              <a:off x="1039132" y="3955386"/>
              <a:ext cx="4074687" cy="1365600"/>
              <a:chOff x="280059" y="2673197"/>
              <a:chExt cx="4074687" cy="1365600"/>
            </a:xfrm>
          </p:grpSpPr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id="{EB291923-7221-0F2F-DC48-E8A4F98BA2A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1395" y="3182439"/>
                <a:ext cx="270226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7CDF73DC-ED9D-B84F-46A0-F460FF17A70F}"/>
                  </a:ext>
                </a:extLst>
              </p:cNvPr>
              <p:cNvSpPr txBox="1"/>
              <p:nvPr/>
            </p:nvSpPr>
            <p:spPr>
              <a:xfrm>
                <a:off x="285847" y="3023134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50</a:t>
                </a:r>
              </a:p>
            </p:txBody>
          </p:sp>
          <p:sp>
            <p:nvSpPr>
              <p:cNvPr id="35" name="ZoneTexte 32">
                <a:extLst>
                  <a:ext uri="{FF2B5EF4-FFF2-40B4-BE49-F238E27FC236}">
                    <a16:creationId xmlns:a16="http://schemas.microsoft.com/office/drawing/2014/main" id="{1E28F33E-6658-DCDC-63AE-178CAF2C27C8}"/>
                  </a:ext>
                </a:extLst>
              </p:cNvPr>
              <p:cNvSpPr txBox="1"/>
              <p:nvPr/>
            </p:nvSpPr>
            <p:spPr>
              <a:xfrm>
                <a:off x="2165236" y="3023134"/>
                <a:ext cx="2189510" cy="10156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/>
                  <a:t>α</a:t>
                </a:r>
                <a:r>
                  <a:rPr lang="en-GB" sz="1200" dirty="0"/>
                  <a:t>-GFP</a:t>
                </a:r>
                <a:endParaRPr lang="fr-FR" sz="1200" dirty="0"/>
              </a:p>
              <a:p>
                <a:r>
                  <a:rPr lang="fr-FR" sz="1200" dirty="0"/>
                  <a:t>Chimiluminescence image</a:t>
                </a:r>
              </a:p>
              <a:p>
                <a:r>
                  <a:rPr lang="fr-FR" sz="1200" dirty="0"/>
                  <a:t>+ Membrane overlay</a:t>
                </a:r>
              </a:p>
              <a:p>
                <a:endParaRPr lang="fr-FR" sz="1200" dirty="0"/>
              </a:p>
              <a:p>
                <a:r>
                  <a:rPr lang="fr-FR" sz="1200" dirty="0">
                    <a:sym typeface="Wingdings" pitchFamily="2" charset="2"/>
                  </a:rPr>
                  <a:t> </a:t>
                </a:r>
                <a:r>
                  <a:rPr lang="fr-FR" sz="1200" dirty="0"/>
                  <a:t>Membrane </a:t>
                </a:r>
                <a:r>
                  <a:rPr lang="fr-FR" sz="1200" dirty="0" err="1"/>
                  <a:t>cut</a:t>
                </a:r>
                <a:r>
                  <a:rPr lang="fr-FR" sz="1200" dirty="0"/>
                  <a:t> </a:t>
                </a:r>
                <a:r>
                  <a:rPr lang="fr-FR" sz="1200" dirty="0" err="1"/>
                  <a:t>above</a:t>
                </a:r>
                <a:r>
                  <a:rPr lang="fr-FR" sz="1200" dirty="0"/>
                  <a:t> 50 kDa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DA50A489-AF4D-5CE0-F6EA-104BDA2021BF}"/>
                  </a:ext>
                </a:extLst>
              </p:cNvPr>
              <p:cNvSpPr txBox="1"/>
              <p:nvPr/>
            </p:nvSpPr>
            <p:spPr>
              <a:xfrm>
                <a:off x="280059" y="2673197"/>
                <a:ext cx="5020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/>
                  <a:t>kDa</a:t>
                </a:r>
                <a:endParaRPr lang="en-US" sz="1600" dirty="0"/>
              </a:p>
            </p:txBody>
          </p:sp>
        </p:grp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D35631D-6815-7177-26D1-940258B3E98E}"/>
                </a:ext>
              </a:extLst>
            </p:cNvPr>
            <p:cNvSpPr txBox="1"/>
            <p:nvPr/>
          </p:nvSpPr>
          <p:spPr>
            <a:xfrm rot="18528072">
              <a:off x="1525715" y="3734984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C00000"/>
                  </a:solidFill>
                </a:rPr>
                <a:t>Ladder</a:t>
              </a: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92EB1246-720E-B8C7-3B15-85714EB92421}"/>
              </a:ext>
            </a:extLst>
          </p:cNvPr>
          <p:cNvGrpSpPr/>
          <p:nvPr/>
        </p:nvGrpSpPr>
        <p:grpSpPr>
          <a:xfrm>
            <a:off x="5429102" y="1094892"/>
            <a:ext cx="4076723" cy="1699257"/>
            <a:chOff x="5434795" y="1222606"/>
            <a:chExt cx="4076723" cy="1699257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B7A0C0FA-8165-A8F4-D3EE-8360AB53497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52720" t="41581" r="22938" b="33595"/>
            <a:stretch/>
          </p:blipFill>
          <p:spPr>
            <a:xfrm>
              <a:off x="5434795" y="1381297"/>
              <a:ext cx="1891952" cy="1540566"/>
            </a:xfrm>
            <a:prstGeom prst="rect">
              <a:avLst/>
            </a:prstGeom>
          </p:spPr>
        </p:pic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id="{839412C0-2600-431D-28A2-70A4D68E0133}"/>
                </a:ext>
              </a:extLst>
            </p:cNvPr>
            <p:cNvGrpSpPr/>
            <p:nvPr/>
          </p:nvGrpSpPr>
          <p:grpSpPr>
            <a:xfrm>
              <a:off x="5768905" y="1222606"/>
              <a:ext cx="3742613" cy="1044982"/>
              <a:chOff x="4837803" y="1327612"/>
              <a:chExt cx="3742613" cy="1044982"/>
            </a:xfrm>
          </p:grpSpPr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6D7E3E00-4826-111D-B114-5322FBD30D4A}"/>
                  </a:ext>
                </a:extLst>
              </p:cNvPr>
              <p:cNvSpPr txBox="1"/>
              <p:nvPr/>
            </p:nvSpPr>
            <p:spPr>
              <a:xfrm>
                <a:off x="4837803" y="1327612"/>
                <a:ext cx="30168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1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DE65174F-B0C6-885D-C6CC-2116774C0F55}"/>
                  </a:ext>
                </a:extLst>
              </p:cNvPr>
              <p:cNvSpPr txBox="1"/>
              <p:nvPr/>
            </p:nvSpPr>
            <p:spPr>
              <a:xfrm>
                <a:off x="5047981" y="1327612"/>
                <a:ext cx="30168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2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539EFDCD-E899-6EEE-709D-D6F0538A474E}"/>
                  </a:ext>
                </a:extLst>
              </p:cNvPr>
              <p:cNvSpPr txBox="1"/>
              <p:nvPr/>
            </p:nvSpPr>
            <p:spPr>
              <a:xfrm>
                <a:off x="5242505" y="1327612"/>
                <a:ext cx="30168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3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92CAA38E-65B0-D5D4-CAFA-E4BAE4182784}"/>
                  </a:ext>
                </a:extLst>
              </p:cNvPr>
              <p:cNvSpPr txBox="1"/>
              <p:nvPr/>
            </p:nvSpPr>
            <p:spPr>
              <a:xfrm>
                <a:off x="5425843" y="1327612"/>
                <a:ext cx="30168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4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1649A896-BB75-7CFF-DA69-0A02694437F9}"/>
                  </a:ext>
                </a:extLst>
              </p:cNvPr>
              <p:cNvSpPr txBox="1"/>
              <p:nvPr/>
            </p:nvSpPr>
            <p:spPr>
              <a:xfrm>
                <a:off x="5629729" y="1327612"/>
                <a:ext cx="30168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5</a:t>
                </a:r>
              </a:p>
            </p:txBody>
          </p:sp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5274B26B-204C-8C52-5789-F76D9DCBF9C2}"/>
                  </a:ext>
                </a:extLst>
              </p:cNvPr>
              <p:cNvSpPr/>
              <p:nvPr/>
            </p:nvSpPr>
            <p:spPr>
              <a:xfrm>
                <a:off x="4837803" y="2005744"/>
                <a:ext cx="1093612" cy="36422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500CD3F2-CAC1-9972-BD05-6CF38C076408}"/>
                  </a:ext>
                </a:extLst>
              </p:cNvPr>
              <p:cNvSpPr txBox="1"/>
              <p:nvPr/>
            </p:nvSpPr>
            <p:spPr>
              <a:xfrm>
                <a:off x="6484523" y="1910929"/>
                <a:ext cx="2095893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l-GR" sz="1200" dirty="0"/>
                  <a:t>α</a:t>
                </a:r>
                <a:r>
                  <a:rPr lang="en-GB" sz="1200" dirty="0"/>
                  <a:t>-</a:t>
                </a:r>
                <a:r>
                  <a:rPr lang="fr-FR" sz="1200" dirty="0" err="1"/>
                  <a:t>Tubulin</a:t>
                </a:r>
                <a:r>
                  <a:rPr lang="fr-FR" sz="1200" dirty="0"/>
                  <a:t> Blot</a:t>
                </a:r>
              </a:p>
              <a:p>
                <a:r>
                  <a:rPr lang="fr-FR" sz="1200" dirty="0"/>
                  <a:t>Chimiluminescence image</a:t>
                </a:r>
                <a:endParaRPr lang="en-US" sz="1200" dirty="0"/>
              </a:p>
            </p:txBody>
          </p:sp>
        </p:grpSp>
      </p:grp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434156EB-E69F-D45A-D40F-9ACE4113E197}"/>
              </a:ext>
            </a:extLst>
          </p:cNvPr>
          <p:cNvCxnSpPr>
            <a:cxnSpLocks/>
          </p:cNvCxnSpPr>
          <p:nvPr/>
        </p:nvCxnSpPr>
        <p:spPr>
          <a:xfrm>
            <a:off x="1096755" y="4404954"/>
            <a:ext cx="270226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2F90F6EC-16A7-9A5B-48C8-B1D1A2300879}"/>
              </a:ext>
            </a:extLst>
          </p:cNvPr>
          <p:cNvSpPr txBox="1"/>
          <p:nvPr/>
        </p:nvSpPr>
        <p:spPr>
          <a:xfrm>
            <a:off x="720039" y="4231338"/>
            <a:ext cx="544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37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14133274-F6F7-175E-1D2C-315DE87583B6}"/>
              </a:ext>
            </a:extLst>
          </p:cNvPr>
          <p:cNvCxnSpPr>
            <a:cxnSpLocks/>
          </p:cNvCxnSpPr>
          <p:nvPr/>
        </p:nvCxnSpPr>
        <p:spPr>
          <a:xfrm>
            <a:off x="1102956" y="4635731"/>
            <a:ext cx="270226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3603F36C-4A6B-D3B8-E01E-7CB222F584EF}"/>
              </a:ext>
            </a:extLst>
          </p:cNvPr>
          <p:cNvSpPr txBox="1"/>
          <p:nvPr/>
        </p:nvSpPr>
        <p:spPr>
          <a:xfrm>
            <a:off x="718689" y="4447053"/>
            <a:ext cx="5445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25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4A8554AB-64E5-9E9B-2146-E6580F153347}"/>
              </a:ext>
            </a:extLst>
          </p:cNvPr>
          <p:cNvGrpSpPr/>
          <p:nvPr/>
        </p:nvGrpSpPr>
        <p:grpSpPr>
          <a:xfrm>
            <a:off x="5260019" y="3165664"/>
            <a:ext cx="4666026" cy="3062218"/>
            <a:chOff x="5260019" y="3165664"/>
            <a:chExt cx="4666026" cy="3062218"/>
          </a:xfrm>
        </p:grpSpPr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B09D9C6B-233A-282B-A04A-24418F4A6923}"/>
                </a:ext>
              </a:extLst>
            </p:cNvPr>
            <p:cNvGrpSpPr/>
            <p:nvPr/>
          </p:nvGrpSpPr>
          <p:grpSpPr>
            <a:xfrm>
              <a:off x="5260020" y="3165664"/>
              <a:ext cx="4666025" cy="3062218"/>
              <a:chOff x="5260020" y="3165664"/>
              <a:chExt cx="4666025" cy="3062218"/>
            </a:xfrm>
          </p:grpSpPr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F2105B32-9602-251C-3F2F-573E08E1415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56132" t="39770" r="20689" b="21790"/>
              <a:stretch/>
            </p:blipFill>
            <p:spPr>
              <a:xfrm>
                <a:off x="5837691" y="3842240"/>
                <a:ext cx="1801604" cy="2385642"/>
              </a:xfrm>
              <a:prstGeom prst="rect">
                <a:avLst/>
              </a:prstGeom>
            </p:spPr>
          </p:pic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C7724702-CFB2-7AE0-93A3-674A2B6BBDB9}"/>
                  </a:ext>
                </a:extLst>
              </p:cNvPr>
              <p:cNvGrpSpPr/>
              <p:nvPr/>
            </p:nvGrpSpPr>
            <p:grpSpPr>
              <a:xfrm>
                <a:off x="5260020" y="3165664"/>
                <a:ext cx="4666025" cy="1830552"/>
                <a:chOff x="4260132" y="2599850"/>
                <a:chExt cx="4666025" cy="1830552"/>
              </a:xfrm>
            </p:grpSpPr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53269FDD-F389-47C1-DA8C-6C0003C5BB05}"/>
                    </a:ext>
                  </a:extLst>
                </p:cNvPr>
                <p:cNvSpPr txBox="1"/>
                <p:nvPr/>
              </p:nvSpPr>
              <p:spPr>
                <a:xfrm rot="18528072">
                  <a:off x="4646731" y="2809844"/>
                  <a:ext cx="75854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>
                      <a:solidFill>
                        <a:srgbClr val="C00000"/>
                      </a:solidFill>
                    </a:rPr>
                    <a:t>Ladder</a:t>
                  </a:r>
                </a:p>
              </p:txBody>
            </p:sp>
            <p:cxnSp>
              <p:nvCxnSpPr>
                <p:cNvPr id="52" name="Straight Connector 51">
                  <a:extLst>
                    <a:ext uri="{FF2B5EF4-FFF2-40B4-BE49-F238E27FC236}">
                      <a16:creationId xmlns:a16="http://schemas.microsoft.com/office/drawing/2014/main" id="{84FCCA68-B6C0-4CF9-A3CB-9ED1DF79B27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628211" y="4071286"/>
                  <a:ext cx="270226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9B3B2A8F-A910-E6B6-F720-15E508EFF1EA}"/>
                    </a:ext>
                  </a:extLst>
                </p:cNvPr>
                <p:cNvSpPr txBox="1"/>
                <p:nvPr/>
              </p:nvSpPr>
              <p:spPr>
                <a:xfrm>
                  <a:off x="4260132" y="3900640"/>
                  <a:ext cx="54455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/>
                    <a:t>50</a:t>
                  </a:r>
                </a:p>
              </p:txBody>
            </p:sp>
            <p:sp>
              <p:nvSpPr>
                <p:cNvPr id="54" name="ZoneTexte 32">
                  <a:extLst>
                    <a:ext uri="{FF2B5EF4-FFF2-40B4-BE49-F238E27FC236}">
                      <a16:creationId xmlns:a16="http://schemas.microsoft.com/office/drawing/2014/main" id="{869A442E-E79A-B99F-AA71-C48F1FFF5C86}"/>
                    </a:ext>
                  </a:extLst>
                </p:cNvPr>
                <p:cNvSpPr txBox="1"/>
                <p:nvPr/>
              </p:nvSpPr>
              <p:spPr>
                <a:xfrm>
                  <a:off x="6672527" y="3414739"/>
                  <a:ext cx="2253630" cy="10156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200" dirty="0"/>
                    <a:t>α</a:t>
                  </a:r>
                  <a:r>
                    <a:rPr lang="en-GB" sz="1200" dirty="0"/>
                    <a:t>-Tubulin</a:t>
                  </a:r>
                  <a:endParaRPr lang="fr-FR" sz="1200" dirty="0"/>
                </a:p>
                <a:p>
                  <a:r>
                    <a:rPr lang="fr-FR" sz="1200" dirty="0"/>
                    <a:t>Chimiluminescence image</a:t>
                  </a:r>
                </a:p>
                <a:p>
                  <a:r>
                    <a:rPr lang="fr-FR" sz="1200" dirty="0"/>
                    <a:t>+ Membrane overlay</a:t>
                  </a:r>
                </a:p>
                <a:p>
                  <a:endParaRPr lang="fr-FR" sz="1200" dirty="0"/>
                </a:p>
                <a:p>
                  <a:r>
                    <a:rPr lang="fr-FR" sz="1200" dirty="0">
                      <a:sym typeface="Wingdings" pitchFamily="2" charset="2"/>
                    </a:rPr>
                    <a:t> </a:t>
                  </a:r>
                  <a:r>
                    <a:rPr lang="fr-FR" sz="1200" dirty="0"/>
                    <a:t>Ladder </a:t>
                  </a:r>
                  <a:r>
                    <a:rPr lang="fr-FR" sz="1200" dirty="0" err="1"/>
                    <a:t>cut</a:t>
                  </a:r>
                  <a:r>
                    <a:rPr lang="fr-FR" sz="1200" dirty="0"/>
                    <a:t> </a:t>
                  </a:r>
                  <a:r>
                    <a:rPr lang="fr-FR" sz="1200" dirty="0" err="1"/>
                    <a:t>halfway</a:t>
                  </a:r>
                  <a:r>
                    <a:rPr lang="fr-FR" sz="1200" dirty="0"/>
                    <a:t> (</a:t>
                  </a:r>
                  <a:r>
                    <a:rPr lang="fr-FR" sz="1200" dirty="0" err="1"/>
                    <a:t>vertically</a:t>
                  </a:r>
                  <a:r>
                    <a:rPr lang="fr-FR" sz="1200" dirty="0"/>
                    <a:t>)</a:t>
                  </a:r>
                </a:p>
              </p:txBody>
            </p:sp>
          </p:grpSp>
        </p:grp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2038AD6D-3F47-05EF-48A9-2C0A1B15A80F}"/>
                </a:ext>
              </a:extLst>
            </p:cNvPr>
            <p:cNvCxnSpPr>
              <a:cxnSpLocks/>
            </p:cNvCxnSpPr>
            <p:nvPr/>
          </p:nvCxnSpPr>
          <p:spPr>
            <a:xfrm>
              <a:off x="5628099" y="4857684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D1D7B73-C4FB-0B83-ACE3-A1B70A8D4E51}"/>
                </a:ext>
              </a:extLst>
            </p:cNvPr>
            <p:cNvSpPr txBox="1"/>
            <p:nvPr/>
          </p:nvSpPr>
          <p:spPr>
            <a:xfrm>
              <a:off x="5260019" y="4675005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3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432239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52</TotalTime>
  <Words>139</Words>
  <Application>Microsoft Macintosh PowerPoint</Application>
  <PresentationFormat>Widescreen</PresentationFormat>
  <Paragraphs>8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Wingdings</vt:lpstr>
      <vt:lpstr>Thèm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almonella Infection for SteE mutants : WT / L89A / G90A / P92A / LGP-AAA</dc:title>
  <dc:creator>Alexi RONNEAU</dc:creator>
  <cp:lastModifiedBy>Thurston, Teresa L M</cp:lastModifiedBy>
  <cp:revision>20</cp:revision>
  <dcterms:created xsi:type="dcterms:W3CDTF">2025-03-06T18:55:09Z</dcterms:created>
  <dcterms:modified xsi:type="dcterms:W3CDTF">2025-03-17T09:44:20Z</dcterms:modified>
</cp:coreProperties>
</file>